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2" r:id="rId2"/>
    <p:sldId id="263" r:id="rId3"/>
    <p:sldId id="257" r:id="rId4"/>
    <p:sldId id="264" r:id="rId5"/>
    <p:sldId id="265" r:id="rId6"/>
    <p:sldId id="266" r:id="rId7"/>
    <p:sldId id="259" r:id="rId8"/>
    <p:sldId id="268" r:id="rId9"/>
    <p:sldId id="269" r:id="rId10"/>
    <p:sldId id="270" r:id="rId11"/>
  </p:sldIdLst>
  <p:sldSz cx="6858000" cy="9144000" type="screen4x3"/>
  <p:notesSz cx="6858000" cy="9144000"/>
  <p:defaultTextStyle>
    <a:defPPr>
      <a:defRPr lang="en-US"/>
    </a:defPPr>
    <a:lvl1pPr marL="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1pPr>
    <a:lvl2pPr marL="3429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2pPr>
    <a:lvl3pPr marL="6858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3pPr>
    <a:lvl4pPr marL="10287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4pPr>
    <a:lvl5pPr marL="13716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5pPr>
    <a:lvl6pPr marL="17145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6pPr>
    <a:lvl7pPr marL="20574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7pPr>
    <a:lvl8pPr marL="24003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8pPr>
    <a:lvl9pPr marL="27432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8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7E456-FEAD-4653-BAAB-9FA48CB30496}" type="datetimeFigureOut">
              <a:rPr lang="en-US" smtClean="0"/>
              <a:t>12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B9FB0-41BF-41A6-901F-3005434464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52616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7E456-FEAD-4653-BAAB-9FA48CB30496}" type="datetimeFigureOut">
              <a:rPr lang="en-US" smtClean="0"/>
              <a:t>12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B9FB0-41BF-41A6-901F-3005434464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326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7E456-FEAD-4653-BAAB-9FA48CB30496}" type="datetimeFigureOut">
              <a:rPr lang="en-US" smtClean="0"/>
              <a:t>12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B9FB0-41BF-41A6-901F-3005434464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5513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7E456-FEAD-4653-BAAB-9FA48CB30496}" type="datetimeFigureOut">
              <a:rPr lang="en-US" smtClean="0"/>
              <a:t>12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B9FB0-41BF-41A6-901F-3005434464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307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7E456-FEAD-4653-BAAB-9FA48CB30496}" type="datetimeFigureOut">
              <a:rPr lang="en-US" smtClean="0"/>
              <a:t>12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B9FB0-41BF-41A6-901F-3005434464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340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7E456-FEAD-4653-BAAB-9FA48CB30496}" type="datetimeFigureOut">
              <a:rPr lang="en-US" smtClean="0"/>
              <a:t>12/3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B9FB0-41BF-41A6-901F-3005434464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2444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7E456-FEAD-4653-BAAB-9FA48CB30496}" type="datetimeFigureOut">
              <a:rPr lang="en-US" smtClean="0"/>
              <a:t>12/3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B9FB0-41BF-41A6-901F-3005434464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622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7E456-FEAD-4653-BAAB-9FA48CB30496}" type="datetimeFigureOut">
              <a:rPr lang="en-US" smtClean="0"/>
              <a:t>12/3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B9FB0-41BF-41A6-901F-3005434464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116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7E456-FEAD-4653-BAAB-9FA48CB30496}" type="datetimeFigureOut">
              <a:rPr lang="en-US" smtClean="0"/>
              <a:t>12/3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B9FB0-41BF-41A6-901F-3005434464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054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7E456-FEAD-4653-BAAB-9FA48CB30496}" type="datetimeFigureOut">
              <a:rPr lang="en-US" smtClean="0"/>
              <a:t>12/3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B9FB0-41BF-41A6-901F-3005434464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327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7E456-FEAD-4653-BAAB-9FA48CB30496}" type="datetimeFigureOut">
              <a:rPr lang="en-US" smtClean="0"/>
              <a:t>12/3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B9FB0-41BF-41A6-901F-3005434464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851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77E456-FEAD-4653-BAAB-9FA48CB30496}" type="datetimeFigureOut">
              <a:rPr lang="en-US" smtClean="0"/>
              <a:t>12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0B9FB0-41BF-41A6-901F-3005434464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9575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640"/>
          <a:stretch/>
        </p:blipFill>
        <p:spPr>
          <a:xfrm>
            <a:off x="338685" y="4436645"/>
            <a:ext cx="6180630" cy="2788102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07663" y="402163"/>
            <a:ext cx="338073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Figure 2B and Figure S2A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3360"/>
          <a:stretch/>
        </p:blipFill>
        <p:spPr>
          <a:xfrm>
            <a:off x="338685" y="1458687"/>
            <a:ext cx="6180630" cy="2437038"/>
          </a:xfrm>
          <a:prstGeom prst="rect">
            <a:avLst/>
          </a:prstGeom>
        </p:spPr>
      </p:pic>
      <p:cxnSp>
        <p:nvCxnSpPr>
          <p:cNvPr id="4" name="Straight Connector 3"/>
          <p:cNvCxnSpPr/>
          <p:nvPr/>
        </p:nvCxnSpPr>
        <p:spPr>
          <a:xfrm>
            <a:off x="4070182" y="2722145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4146382" y="3503195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5584657" y="2722145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5666371" y="3503195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4151394" y="5872915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5680908" y="5872915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996901" y="3889929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.0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244982" y="3889929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.4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980116" y="3889929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02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282775" y="3889929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02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530858" y="3889929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0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827841" y="3889929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09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058580" y="3889929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.22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306662" y="3889929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04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546495" y="3889929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03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506267" y="3889929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27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754349" y="3889929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08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787850" y="3895150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2.36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35932" y="3895150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.48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996901" y="4100152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.00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244982" y="4100152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.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980116" y="4100152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79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257127" y="4100152"/>
            <a:ext cx="4154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27.14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505211" y="4100152"/>
            <a:ext cx="4154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3.32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827841" y="4100152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58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32931" y="4100152"/>
            <a:ext cx="4154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21.94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281013" y="4100152"/>
            <a:ext cx="4154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21.37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546494" y="4100152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8.86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506267" y="4100152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2.23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754349" y="4100152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.82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4762202" y="4105373"/>
            <a:ext cx="4154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8.14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5035932" y="4105373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2.67</a:t>
            </a:r>
          </a:p>
        </p:txBody>
      </p:sp>
    </p:spTree>
    <p:extLst>
      <p:ext uri="{BB962C8B-B14F-4D97-AF65-F5344CB8AC3E}">
        <p14:creationId xmlns:p14="http://schemas.microsoft.com/office/powerpoint/2010/main" val="22466196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7663" y="402163"/>
            <a:ext cx="227857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Figure S3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2" r="7778" b="70358"/>
          <a:stretch/>
        </p:blipFill>
        <p:spPr>
          <a:xfrm>
            <a:off x="76199" y="854643"/>
            <a:ext cx="6669937" cy="224098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2" t="54211" r="7778" b="20591"/>
          <a:stretch/>
        </p:blipFill>
        <p:spPr>
          <a:xfrm>
            <a:off x="76199" y="5715000"/>
            <a:ext cx="6669937" cy="190499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2" t="29734" r="7778" b="45698"/>
          <a:stretch/>
        </p:blipFill>
        <p:spPr>
          <a:xfrm>
            <a:off x="76199" y="3495675"/>
            <a:ext cx="6669937" cy="185737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84408" y="309562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61625" y="309562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4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53250" y="309562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3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251208" y="309562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428425" y="309562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71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620050" y="309562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58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371405" y="309562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548622" y="309562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29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740247" y="309562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39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57326" y="531755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34543" y="531755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49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26168" y="531755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2.6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230463" y="531622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407680" y="531622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6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599305" y="531622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2.14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57326" y="7519971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34543" y="7519971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0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26168" y="7519971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00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699133" y="3090601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876350" y="3090601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38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067975" y="3090601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37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4766930" y="3100589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944147" y="3100589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2.33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5135772" y="3100589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3.04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5834727" y="3100589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6011944" y="3100589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2.1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6203569" y="3100589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66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699133" y="531467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876350" y="531467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55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4067975" y="531467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65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4739848" y="531467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917065" y="531467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64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108690" y="5314675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69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720982" y="7519969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3898199" y="7519969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00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089824" y="7519969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00</a:t>
            </a:r>
          </a:p>
        </p:txBody>
      </p:sp>
    </p:spTree>
    <p:extLst>
      <p:ext uri="{BB962C8B-B14F-4D97-AF65-F5344CB8AC3E}">
        <p14:creationId xmlns:p14="http://schemas.microsoft.com/office/powerpoint/2010/main" val="39857158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7663" y="402163"/>
            <a:ext cx="229780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Figure 3A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48" b="16032"/>
          <a:stretch/>
        </p:blipFill>
        <p:spPr>
          <a:xfrm>
            <a:off x="405634" y="869693"/>
            <a:ext cx="6237514" cy="6619678"/>
          </a:xfrm>
          <a:prstGeom prst="rect">
            <a:avLst/>
          </a:prstGeom>
          <a:solidFill>
            <a:schemeClr val="bg1"/>
          </a:solidFill>
          <a:ln>
            <a:noFill/>
          </a:ln>
        </p:spPr>
      </p:pic>
      <p:sp>
        <p:nvSpPr>
          <p:cNvPr id="4" name="Rectangle 3"/>
          <p:cNvSpPr/>
          <p:nvPr/>
        </p:nvSpPr>
        <p:spPr>
          <a:xfrm>
            <a:off x="3406141" y="6522720"/>
            <a:ext cx="45719" cy="1676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769997" y="2737388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51403" y="27373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6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134086" y="27373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56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474847" y="2737388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656253" y="27373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17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838936" y="27373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41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203026" y="2737388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384432" y="27373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74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567115" y="27373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50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3079784" y="4265195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6118057" y="4665245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3779897" y="4937663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961303" y="49376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3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143986" y="49376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15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484747" y="4937663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666153" y="49376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07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848836" y="49376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05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212926" y="4937663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5394332" y="49376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31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577015" y="49376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47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47668" y="7290947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929074" y="7290947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43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111757" y="7290947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66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452518" y="7290947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633924" y="7290947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55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816607" y="7290947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44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180697" y="7290947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2362103" y="7290947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32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544786" y="7290947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26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779897" y="729013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3961303" y="7290131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23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4143986" y="7290131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2.10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484747" y="729013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4666153" y="7290131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47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848836" y="7290131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13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5212926" y="729013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5394332" y="7290131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93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5577015" y="729013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13</a:t>
            </a:r>
          </a:p>
        </p:txBody>
      </p:sp>
    </p:spTree>
    <p:extLst>
      <p:ext uri="{BB962C8B-B14F-4D97-AF65-F5344CB8AC3E}">
        <p14:creationId xmlns:p14="http://schemas.microsoft.com/office/powerpoint/2010/main" val="23389794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7213" y="702245"/>
            <a:ext cx="1993565" cy="301320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56098" y="702245"/>
            <a:ext cx="2002709" cy="301320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7663" y="702245"/>
            <a:ext cx="2057579" cy="303149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57213" y="4390522"/>
            <a:ext cx="1993565" cy="301320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6250" y="4395094"/>
            <a:ext cx="1979848" cy="300863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78959" y="4390522"/>
            <a:ext cx="1979848" cy="301320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07663" y="402163"/>
            <a:ext cx="229139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Figure 3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30568" y="3756827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1.0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256902" y="3756827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6.14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846937" y="3756827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1.0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273272" y="3756827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1.98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863014" y="7441222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1.0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289348" y="7441222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3.59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846937" y="7441222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1.0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273272" y="7441222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1.83</a:t>
            </a:r>
          </a:p>
        </p:txBody>
      </p:sp>
    </p:spTree>
    <p:extLst>
      <p:ext uri="{BB962C8B-B14F-4D97-AF65-F5344CB8AC3E}">
        <p14:creationId xmlns:p14="http://schemas.microsoft.com/office/powerpoint/2010/main" val="39300026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7663" y="402163"/>
            <a:ext cx="74982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4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573" y="1218624"/>
            <a:ext cx="5068389" cy="258644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91826" y="3609419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0.67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518159" y="3609419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2.47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930709" y="3609419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0.13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309526" y="3609419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1.0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539751" y="3609419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0.83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966084" y="3609419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1.22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378634" y="3609419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0.3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757451" y="3609419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1.00</a:t>
            </a:r>
          </a:p>
        </p:txBody>
      </p:sp>
    </p:spTree>
    <p:extLst>
      <p:ext uri="{BB962C8B-B14F-4D97-AF65-F5344CB8AC3E}">
        <p14:creationId xmlns:p14="http://schemas.microsoft.com/office/powerpoint/2010/main" val="28500525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2"/>
          <a:srcRect t="66705"/>
          <a:stretch/>
        </p:blipFill>
        <p:spPr>
          <a:xfrm>
            <a:off x="111331" y="5200623"/>
            <a:ext cx="6626926" cy="204203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07663" y="402163"/>
            <a:ext cx="229780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Figure 6A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9" r="1905" b="32857"/>
          <a:stretch/>
        </p:blipFill>
        <p:spPr>
          <a:xfrm>
            <a:off x="108857" y="800493"/>
            <a:ext cx="6629400" cy="4114408"/>
          </a:xfrm>
          <a:prstGeom prst="rect">
            <a:avLst/>
          </a:prstGeom>
        </p:spPr>
      </p:pic>
      <p:cxnSp>
        <p:nvCxnSpPr>
          <p:cNvPr id="22" name="Straight Connector 21"/>
          <p:cNvCxnSpPr/>
          <p:nvPr/>
        </p:nvCxnSpPr>
        <p:spPr>
          <a:xfrm>
            <a:off x="2879557" y="2474495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6318082" y="1979195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2927182" y="4160420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2879557" y="6817895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6346657" y="6351170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303285" y="491312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84691" y="491312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59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667374" y="491312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48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849670" y="491312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35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121525" y="491312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302261" y="491312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60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480014" y="491312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33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652785" y="491312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18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874770" y="491312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2050911" y="491312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63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228664" y="491312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33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2406030" y="4913121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08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331847" y="6956963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513253" y="69569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91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695936" y="69569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29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878232" y="69569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28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1150087" y="6956963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330823" y="69569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35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508576" y="69569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68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681347" y="69569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58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1903332" y="6956963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079473" y="69569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90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2257226" y="69569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25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2434592" y="6956963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6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744155" y="2851688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925561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51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4108244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34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4290540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49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4562395" y="2851688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4743131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31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4920884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38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5093655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23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5315640" y="2851688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5491781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31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5669534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22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5846900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21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331847" y="2851688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513253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25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695936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25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878232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52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1150087" y="2851688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1330823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45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1508576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22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1681347" y="2851688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18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1903332" y="2851688"/>
            <a:ext cx="3417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1.00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2079473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54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2257226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45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2434592" y="2851688"/>
            <a:ext cx="3417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/>
              <a:t>0.87</a:t>
            </a:r>
          </a:p>
        </p:txBody>
      </p:sp>
      <p:cxnSp>
        <p:nvCxnSpPr>
          <p:cNvPr id="79" name="Straight Connector 78"/>
          <p:cNvCxnSpPr/>
          <p:nvPr/>
        </p:nvCxnSpPr>
        <p:spPr>
          <a:xfrm>
            <a:off x="6337132" y="1817270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217128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674"/>
          <a:stretch/>
        </p:blipFill>
        <p:spPr>
          <a:xfrm>
            <a:off x="-2" y="4376646"/>
            <a:ext cx="6773897" cy="286319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07663" y="402163"/>
            <a:ext cx="22930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Figure 6B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9203"/>
          <a:stretch/>
        </p:blipFill>
        <p:spPr>
          <a:xfrm>
            <a:off x="-1" y="927683"/>
            <a:ext cx="6773897" cy="3009616"/>
          </a:xfrm>
          <a:prstGeom prst="rect">
            <a:avLst/>
          </a:prstGeom>
        </p:spPr>
      </p:pic>
      <p:cxnSp>
        <p:nvCxnSpPr>
          <p:cNvPr id="4" name="Straight Connector 3"/>
          <p:cNvCxnSpPr/>
          <p:nvPr/>
        </p:nvCxnSpPr>
        <p:spPr>
          <a:xfrm>
            <a:off x="2984332" y="7036182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6308557" y="6988557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4794082" y="6217032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334086" y="3937299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0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40394" y="3937299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0.88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85807" y="3937299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97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930680" y="3937299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0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236988" y="3937299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81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482401" y="3937299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57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703022" y="3914982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0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977056" y="3914982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4.58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254743" y="3914982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5.26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299616" y="3914982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0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605924" y="3914982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93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851337" y="3914982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82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34086" y="7155430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0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40394" y="7155430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0.93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85807" y="7155430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14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930680" y="7155430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0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236989" y="7155430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0.19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482401" y="7155430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0.18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703022" y="7133113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0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977056" y="7133113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19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4254743" y="7133113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18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5299616" y="7133113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1.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5605924" y="7133113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0.04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5851337" y="7133113"/>
            <a:ext cx="386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0.03</a:t>
            </a:r>
          </a:p>
        </p:txBody>
      </p:sp>
    </p:spTree>
    <p:extLst>
      <p:ext uri="{BB962C8B-B14F-4D97-AF65-F5344CB8AC3E}">
        <p14:creationId xmlns:p14="http://schemas.microsoft.com/office/powerpoint/2010/main" val="24145519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2362" y="1342968"/>
            <a:ext cx="1746656" cy="303607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1620" y="1342968"/>
            <a:ext cx="1988993" cy="303607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42362" y="5259110"/>
            <a:ext cx="2002709" cy="303149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76193" y="5259110"/>
            <a:ext cx="1984420" cy="302235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07663" y="402163"/>
            <a:ext cx="84279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C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746063" y="828146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1.0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172395" y="828146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6.0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445719" y="4379039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1.0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872050" y="4379039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0.5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746063" y="4379039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1.0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172394" y="4379039"/>
            <a:ext cx="458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1.49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445719" y="828146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1.0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872050" y="828146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2.10</a:t>
            </a:r>
          </a:p>
        </p:txBody>
      </p:sp>
    </p:spTree>
    <p:extLst>
      <p:ext uri="{BB962C8B-B14F-4D97-AF65-F5344CB8AC3E}">
        <p14:creationId xmlns:p14="http://schemas.microsoft.com/office/powerpoint/2010/main" val="19311878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513"/>
          <a:stretch/>
        </p:blipFill>
        <p:spPr>
          <a:xfrm>
            <a:off x="769135" y="3933824"/>
            <a:ext cx="5115560" cy="179582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07663" y="402163"/>
            <a:ext cx="237154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Figure S2C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723"/>
          <a:stretch/>
        </p:blipFill>
        <p:spPr>
          <a:xfrm>
            <a:off x="769135" y="1388126"/>
            <a:ext cx="5115560" cy="2231374"/>
          </a:xfrm>
          <a:prstGeom prst="rect">
            <a:avLst/>
          </a:prstGeom>
        </p:spPr>
      </p:pic>
      <p:cxnSp>
        <p:nvCxnSpPr>
          <p:cNvPr id="4" name="Straight Connector 3"/>
          <p:cNvCxnSpPr/>
          <p:nvPr/>
        </p:nvCxnSpPr>
        <p:spPr>
          <a:xfrm>
            <a:off x="5403682" y="4817645"/>
            <a:ext cx="3168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1263601" y="3569478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.0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02157" y="3569478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25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751515" y="3569478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4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971910" y="3569478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.0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175241" y="3569478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16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404273" y="3569478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22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634580" y="3569478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.0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854977" y="3569478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11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085285" y="3569478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1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315592" y="3569478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.0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255151" y="3569478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.0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504510" y="3569478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08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763393" y="3569478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08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564949" y="3569478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03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799967" y="3569478"/>
            <a:ext cx="364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0.02</a:t>
            </a:r>
          </a:p>
        </p:txBody>
      </p:sp>
    </p:spTree>
    <p:extLst>
      <p:ext uri="{BB962C8B-B14F-4D97-AF65-F5344CB8AC3E}">
        <p14:creationId xmlns:p14="http://schemas.microsoft.com/office/powerpoint/2010/main" val="1756321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7663" y="402163"/>
            <a:ext cx="238757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Figure S2G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4" t="4782" r="3889"/>
          <a:stretch/>
        </p:blipFill>
        <p:spPr>
          <a:xfrm>
            <a:off x="631519" y="2700510"/>
            <a:ext cx="5593012" cy="267438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305429" y="515945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1.00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582085" y="515945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0.74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860018" y="515945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0.36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128039" y="515945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0.19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388520" y="515945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0.14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220779" y="515945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1.0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555862" y="515945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1.06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852845" y="515945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0.89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158770" y="515945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1.08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654942" y="515945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0.09</a:t>
            </a:r>
          </a:p>
        </p:txBody>
      </p:sp>
    </p:spTree>
    <p:extLst>
      <p:ext uri="{BB962C8B-B14F-4D97-AF65-F5344CB8AC3E}">
        <p14:creationId xmlns:p14="http://schemas.microsoft.com/office/powerpoint/2010/main" val="17804672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CAEACE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00</TotalTime>
  <Words>274</Words>
  <Application>Microsoft Office PowerPoint</Application>
  <PresentationFormat>On-screen Show (4:3)</PresentationFormat>
  <Paragraphs>229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 Yeung,Chi Lam</dc:creator>
  <cp:lastModifiedBy>mdpi</cp:lastModifiedBy>
  <cp:revision>48</cp:revision>
  <dcterms:created xsi:type="dcterms:W3CDTF">2018-04-26T23:44:46Z</dcterms:created>
  <dcterms:modified xsi:type="dcterms:W3CDTF">2019-12-31T01:07:32Z</dcterms:modified>
</cp:coreProperties>
</file>